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3" r:id="rId2"/>
    <p:sldId id="265" r:id="rId3"/>
  </p:sldIdLst>
  <p:sldSz cx="7099300" cy="99441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32" userDrawn="1">
          <p15:clr>
            <a:srgbClr val="A4A3A4"/>
          </p15:clr>
        </p15:guide>
        <p15:guide id="2" pos="223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ves Harder" initials="YH" lastIdx="4" clrIdx="0">
    <p:extLst>
      <p:ext uri="{19B8F6BF-5375-455C-9EA6-DF929625EA0E}">
        <p15:presenceInfo xmlns:p15="http://schemas.microsoft.com/office/powerpoint/2012/main" userId="27fbeea7080a212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74"/>
    <p:restoredTop sz="96197"/>
  </p:normalViewPr>
  <p:slideViewPr>
    <p:cSldViewPr snapToGrid="0" showGuides="1">
      <p:cViewPr varScale="1">
        <p:scale>
          <a:sx n="50" d="100"/>
          <a:sy n="50" d="100"/>
        </p:scale>
        <p:origin x="1812" y="54"/>
      </p:cViewPr>
      <p:guideLst>
        <p:guide orient="horz" pos="3132"/>
        <p:guide pos="22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4-08-21T10:54:16.044" idx="4">
    <p:pos x="1850" y="3962"/>
    <p:text>@ editorial tam: 1 or one? See also figure legend figure 4</p:text>
    <p:extLst>
      <p:ext uri="{C676402C-5697-4E1C-873F-D02D1690AC5C}">
        <p15:threadingInfo xmlns:p15="http://schemas.microsoft.com/office/powerpoint/2012/main" timeZoneBias="-12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2448" y="1627426"/>
            <a:ext cx="6034405" cy="3462020"/>
          </a:xfrm>
        </p:spPr>
        <p:txBody>
          <a:bodyPr anchor="b"/>
          <a:lstStyle>
            <a:lvl1pPr algn="ctr">
              <a:defRPr sz="4658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87413" y="5222955"/>
            <a:ext cx="5324475" cy="2400855"/>
          </a:xfrm>
        </p:spPr>
        <p:txBody>
          <a:bodyPr/>
          <a:lstStyle>
            <a:lvl1pPr marL="0" indent="0" algn="ctr">
              <a:buNone/>
              <a:defRPr sz="1863"/>
            </a:lvl1pPr>
            <a:lvl2pPr marL="354970" indent="0" algn="ctr">
              <a:buNone/>
              <a:defRPr sz="1553"/>
            </a:lvl2pPr>
            <a:lvl3pPr marL="709940" indent="0" algn="ctr">
              <a:buNone/>
              <a:defRPr sz="1398"/>
            </a:lvl3pPr>
            <a:lvl4pPr marL="1064910" indent="0" algn="ctr">
              <a:buNone/>
              <a:defRPr sz="1242"/>
            </a:lvl4pPr>
            <a:lvl5pPr marL="1419880" indent="0" algn="ctr">
              <a:buNone/>
              <a:defRPr sz="1242"/>
            </a:lvl5pPr>
            <a:lvl6pPr marL="1774850" indent="0" algn="ctr">
              <a:buNone/>
              <a:defRPr sz="1242"/>
            </a:lvl6pPr>
            <a:lvl7pPr marL="2129820" indent="0" algn="ctr">
              <a:buNone/>
              <a:defRPr sz="1242"/>
            </a:lvl7pPr>
            <a:lvl8pPr marL="2484791" indent="0" algn="ctr">
              <a:buNone/>
              <a:defRPr sz="1242"/>
            </a:lvl8pPr>
            <a:lvl9pPr marL="2839761" indent="0" algn="ctr">
              <a:buNone/>
              <a:defRPr sz="1242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5042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5956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80437" y="529431"/>
            <a:ext cx="1530787" cy="8427165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8077" y="529431"/>
            <a:ext cx="4503618" cy="8427165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3107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7761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380" y="2479122"/>
            <a:ext cx="6123146" cy="4136469"/>
          </a:xfrm>
        </p:spPr>
        <p:txBody>
          <a:bodyPr anchor="b"/>
          <a:lstStyle>
            <a:lvl1pPr>
              <a:defRPr sz="4658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80" y="6654724"/>
            <a:ext cx="6123146" cy="2175271"/>
          </a:xfrm>
        </p:spPr>
        <p:txBody>
          <a:bodyPr/>
          <a:lstStyle>
            <a:lvl1pPr marL="0" indent="0">
              <a:buNone/>
              <a:defRPr sz="1863">
                <a:solidFill>
                  <a:schemeClr val="tx1">
                    <a:tint val="82000"/>
                  </a:schemeClr>
                </a:solidFill>
              </a:defRPr>
            </a:lvl1pPr>
            <a:lvl2pPr marL="354970" indent="0">
              <a:buNone/>
              <a:defRPr sz="1553">
                <a:solidFill>
                  <a:schemeClr val="tx1">
                    <a:tint val="82000"/>
                  </a:schemeClr>
                </a:solidFill>
              </a:defRPr>
            </a:lvl2pPr>
            <a:lvl3pPr marL="709940" indent="0">
              <a:buNone/>
              <a:defRPr sz="1398">
                <a:solidFill>
                  <a:schemeClr val="tx1">
                    <a:tint val="82000"/>
                  </a:schemeClr>
                </a:solidFill>
              </a:defRPr>
            </a:lvl3pPr>
            <a:lvl4pPr marL="106491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4pPr>
            <a:lvl5pPr marL="141988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5pPr>
            <a:lvl6pPr marL="177485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6pPr>
            <a:lvl7pPr marL="212982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7pPr>
            <a:lvl8pPr marL="248479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8pPr>
            <a:lvl9pPr marL="283976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4730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8077" y="2647156"/>
            <a:ext cx="3017203" cy="6309440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4020" y="2647156"/>
            <a:ext cx="3017203" cy="6309440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6157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529434"/>
            <a:ext cx="6123146" cy="1922066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9002" y="2437687"/>
            <a:ext cx="3003336" cy="119467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9002" y="3632359"/>
            <a:ext cx="3003336" cy="534265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94021" y="2437687"/>
            <a:ext cx="3018127" cy="119467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94021" y="3632359"/>
            <a:ext cx="3018127" cy="534265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1769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0748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0003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940"/>
            <a:ext cx="2289709" cy="232029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18127" y="1431769"/>
            <a:ext cx="3594021" cy="7066756"/>
          </a:xfrm>
        </p:spPr>
        <p:txBody>
          <a:bodyPr/>
          <a:lstStyle>
            <a:lvl1pPr>
              <a:defRPr sz="2484"/>
            </a:lvl1pPr>
            <a:lvl2pPr>
              <a:defRPr sz="2174"/>
            </a:lvl2pPr>
            <a:lvl3pPr>
              <a:defRPr sz="1863"/>
            </a:lvl3pPr>
            <a:lvl4pPr>
              <a:defRPr sz="1553"/>
            </a:lvl4pPr>
            <a:lvl5pPr>
              <a:defRPr sz="1553"/>
            </a:lvl5pPr>
            <a:lvl6pPr>
              <a:defRPr sz="1553"/>
            </a:lvl6pPr>
            <a:lvl7pPr>
              <a:defRPr sz="1553"/>
            </a:lvl7pPr>
            <a:lvl8pPr>
              <a:defRPr sz="1553"/>
            </a:lvl8pPr>
            <a:lvl9pPr>
              <a:defRPr sz="1553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3230"/>
            <a:ext cx="2289709" cy="5526803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10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940"/>
            <a:ext cx="2289709" cy="232029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18127" y="1431769"/>
            <a:ext cx="3594021" cy="7066756"/>
          </a:xfrm>
        </p:spPr>
        <p:txBody>
          <a:bodyPr anchor="t"/>
          <a:lstStyle>
            <a:lvl1pPr marL="0" indent="0">
              <a:buNone/>
              <a:defRPr sz="2484"/>
            </a:lvl1pPr>
            <a:lvl2pPr marL="354970" indent="0">
              <a:buNone/>
              <a:defRPr sz="2174"/>
            </a:lvl2pPr>
            <a:lvl3pPr marL="709940" indent="0">
              <a:buNone/>
              <a:defRPr sz="1863"/>
            </a:lvl3pPr>
            <a:lvl4pPr marL="1064910" indent="0">
              <a:buNone/>
              <a:defRPr sz="1553"/>
            </a:lvl4pPr>
            <a:lvl5pPr marL="1419880" indent="0">
              <a:buNone/>
              <a:defRPr sz="1553"/>
            </a:lvl5pPr>
            <a:lvl6pPr marL="1774850" indent="0">
              <a:buNone/>
              <a:defRPr sz="1553"/>
            </a:lvl6pPr>
            <a:lvl7pPr marL="2129820" indent="0">
              <a:buNone/>
              <a:defRPr sz="1553"/>
            </a:lvl7pPr>
            <a:lvl8pPr marL="2484791" indent="0">
              <a:buNone/>
              <a:defRPr sz="1553"/>
            </a:lvl8pPr>
            <a:lvl9pPr marL="2839761" indent="0">
              <a:buNone/>
              <a:defRPr sz="1553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3230"/>
            <a:ext cx="2289709" cy="5526803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0488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8077" y="529434"/>
            <a:ext cx="6123146" cy="192206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8077" y="2647156"/>
            <a:ext cx="6123146" cy="63094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8077" y="9216710"/>
            <a:ext cx="1597343" cy="5294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0F4ADA3-177A-6C42-BD77-F4B395FBF8A3}" type="datetimeFigureOut">
              <a:rPr lang="it-IT" smtClean="0"/>
              <a:t>21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51643" y="9216710"/>
            <a:ext cx="2396014" cy="5294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13880" y="9216710"/>
            <a:ext cx="1597343" cy="5294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170CF4-3B75-8245-A652-A72A540FDAC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3202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09940" rtl="0" eaLnBrk="1" latinLnBrk="0" hangingPunct="1">
        <a:lnSpc>
          <a:spcPct val="90000"/>
        </a:lnSpc>
        <a:spcBef>
          <a:spcPct val="0"/>
        </a:spcBef>
        <a:buNone/>
        <a:defRPr sz="34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7485" indent="-177485" algn="l" defTabSz="709940" rtl="0" eaLnBrk="1" latinLnBrk="0" hangingPunct="1">
        <a:lnSpc>
          <a:spcPct val="90000"/>
        </a:lnSpc>
        <a:spcBef>
          <a:spcPts val="776"/>
        </a:spcBef>
        <a:buFont typeface="Arial" panose="020B0604020202020204" pitchFamily="34" charset="0"/>
        <a:buChar char="•"/>
        <a:defRPr sz="2174" kern="1200">
          <a:solidFill>
            <a:schemeClr val="tx1"/>
          </a:solidFill>
          <a:latin typeface="+mn-lt"/>
          <a:ea typeface="+mn-ea"/>
          <a:cs typeface="+mn-cs"/>
        </a:defRPr>
      </a:lvl1pPr>
      <a:lvl2pPr marL="53245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863" kern="1200">
          <a:solidFill>
            <a:schemeClr val="tx1"/>
          </a:solidFill>
          <a:latin typeface="+mn-lt"/>
          <a:ea typeface="+mn-ea"/>
          <a:cs typeface="+mn-cs"/>
        </a:defRPr>
      </a:lvl2pPr>
      <a:lvl3pPr marL="88742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553" kern="1200">
          <a:solidFill>
            <a:schemeClr val="tx1"/>
          </a:solidFill>
          <a:latin typeface="+mn-lt"/>
          <a:ea typeface="+mn-ea"/>
          <a:cs typeface="+mn-cs"/>
        </a:defRPr>
      </a:lvl3pPr>
      <a:lvl4pPr marL="124239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59736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95233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30730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66227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301724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1pPr>
      <a:lvl2pPr marL="35497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2pPr>
      <a:lvl3pPr marL="70994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3pPr>
      <a:lvl4pPr marL="106491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41988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77485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12982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48479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283976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4" Type="http://schemas.openxmlformats.org/officeDocument/2006/relationships/comments" Target="../comments/commen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E8D9FF-07EE-D233-09A0-3FAC5CB2CC7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 descr="Immagine che contiene Viso umano, persona, uomo, vestiti&#10;&#10;Descrizione generata automaticamente">
            <a:extLst>
              <a:ext uri="{FF2B5EF4-FFF2-40B4-BE49-F238E27FC236}">
                <a16:creationId xmlns:a16="http://schemas.microsoft.com/office/drawing/2014/main" id="{4485DF31-3DCA-F032-F656-E0F9F221B96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79693" y="3792276"/>
            <a:ext cx="1603875" cy="2174972"/>
          </a:xfrm>
          <a:prstGeom prst="rect">
            <a:avLst/>
          </a:prstGeom>
        </p:spPr>
      </p:pic>
      <p:pic>
        <p:nvPicPr>
          <p:cNvPr id="8" name="Immagine 7" descr="Immagine che contiene Viso umano, persona, Barba umana, uomo&#10;&#10;Descrizione generata automaticamente">
            <a:extLst>
              <a:ext uri="{FF2B5EF4-FFF2-40B4-BE49-F238E27FC236}">
                <a16:creationId xmlns:a16="http://schemas.microsoft.com/office/drawing/2014/main" id="{939B1E82-C088-7E0C-4230-953A4F5264E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75817" y="3792276"/>
            <a:ext cx="1603875" cy="2174972"/>
          </a:xfrm>
          <a:prstGeom prst="rect">
            <a:avLst/>
          </a:prstGeom>
        </p:spPr>
      </p:pic>
      <p:pic>
        <p:nvPicPr>
          <p:cNvPr id="6" name="Immagine 5" descr="Immagine che contiene Viso umano, persona, cielo, Barba umana&#10;&#10;Descrizione generata automaticamente">
            <a:extLst>
              <a:ext uri="{FF2B5EF4-FFF2-40B4-BE49-F238E27FC236}">
                <a16:creationId xmlns:a16="http://schemas.microsoft.com/office/drawing/2014/main" id="{6F68DF4D-DC7C-6C60-217A-0B7E482A016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09748" y="3792276"/>
            <a:ext cx="1466067" cy="2174972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BE975167-5CB7-848F-F348-2FD5922D0FBC}"/>
              </a:ext>
            </a:extLst>
          </p:cNvPr>
          <p:cNvSpPr txBox="1"/>
          <p:nvPr/>
        </p:nvSpPr>
        <p:spPr>
          <a:xfrm>
            <a:off x="1209746" y="5967245"/>
            <a:ext cx="4673820" cy="808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8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Figure S1: </a:t>
            </a:r>
            <a:r>
              <a:rPr lang="en-US" sz="8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(A) </a:t>
            </a:r>
            <a:r>
              <a:rPr lang="en-US" sz="800" dirty="0">
                <a:solidFill>
                  <a:srgbClr val="FF0000"/>
                </a:solidFill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Severe </a:t>
            </a:r>
            <a:r>
              <a:rPr lang="en-US" sz="8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emporal hollowing </a:t>
            </a:r>
            <a:r>
              <a:rPr lang="en-US" sz="800" dirty="0">
                <a:solidFill>
                  <a:srgbClr val="FF0000"/>
                </a:solidFill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on the right, </a:t>
            </a:r>
            <a:r>
              <a:rPr lang="en-US" sz="8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wo years after right </a:t>
            </a:r>
            <a:r>
              <a:rPr lang="en-US" sz="8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fronto</a:t>
            </a:r>
            <a:r>
              <a:rPr lang="en-US" sz="8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-temporal decompressive craniectomy with concomitant severe peri-zygomatic bulging. (B) After two sessions of autologous fat grafting (20 and 30 ml). (C) </a:t>
            </a:r>
            <a:r>
              <a:rPr lang="en-US" sz="800" dirty="0">
                <a:solidFill>
                  <a:srgbClr val="FF0000"/>
                </a:solidFill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Eighteen </a:t>
            </a:r>
            <a:r>
              <a:rPr lang="en-US" sz="8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onths after </a:t>
            </a:r>
            <a:r>
              <a:rPr lang="en-US" sz="800" dirty="0">
                <a:latin typeface="Palatino Linotype" panose="02040502050505030304" pitchFamily="18" charset="0"/>
                <a:ea typeface="Arial" panose="020B0604020202020204" pitchFamily="34" charset="0"/>
              </a:rPr>
              <a:t>inset of a unilateral double-layered adipo-dermal graft harvested from the supra-pubic area.</a:t>
            </a:r>
            <a:endParaRPr lang="en-US" sz="800" dirty="0">
              <a:latin typeface="Palatino Linotype" panose="02040502050505030304" pitchFamily="18" charset="0"/>
              <a:ea typeface="Palatino" pitchFamily="2" charset="77"/>
              <a:cs typeface="Arial" panose="020B0604020202020204" pitchFamily="34" charset="0"/>
            </a:endParaRPr>
          </a:p>
        </p:txBody>
      </p:sp>
      <p:sp>
        <p:nvSpPr>
          <p:cNvPr id="12" name="Ovale 11">
            <a:extLst>
              <a:ext uri="{FF2B5EF4-FFF2-40B4-BE49-F238E27FC236}">
                <a16:creationId xmlns:a16="http://schemas.microsoft.com/office/drawing/2014/main" id="{013AF080-BB7E-C551-65CA-056E0C8AD925}"/>
              </a:ext>
            </a:extLst>
          </p:cNvPr>
          <p:cNvSpPr/>
          <p:nvPr/>
        </p:nvSpPr>
        <p:spPr>
          <a:xfrm>
            <a:off x="3549655" y="4659561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13" name="Ovale 12">
            <a:extLst>
              <a:ext uri="{FF2B5EF4-FFF2-40B4-BE49-F238E27FC236}">
                <a16:creationId xmlns:a16="http://schemas.microsoft.com/office/drawing/2014/main" id="{879B3A9B-9DF6-8224-87CE-016D1919795D}"/>
              </a:ext>
            </a:extLst>
          </p:cNvPr>
          <p:cNvSpPr/>
          <p:nvPr/>
        </p:nvSpPr>
        <p:spPr>
          <a:xfrm>
            <a:off x="2995794" y="4659561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14" name="Ovale 13">
            <a:extLst>
              <a:ext uri="{FF2B5EF4-FFF2-40B4-BE49-F238E27FC236}">
                <a16:creationId xmlns:a16="http://schemas.microsoft.com/office/drawing/2014/main" id="{78962387-1FFD-67A1-EF7D-D70E8BA8C929}"/>
              </a:ext>
            </a:extLst>
          </p:cNvPr>
          <p:cNvSpPr/>
          <p:nvPr/>
        </p:nvSpPr>
        <p:spPr>
          <a:xfrm>
            <a:off x="4599670" y="4573689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15" name="Ovale 14">
            <a:extLst>
              <a:ext uri="{FF2B5EF4-FFF2-40B4-BE49-F238E27FC236}">
                <a16:creationId xmlns:a16="http://schemas.microsoft.com/office/drawing/2014/main" id="{43509819-8292-24E5-3555-A4D4EA4AE38A}"/>
              </a:ext>
            </a:extLst>
          </p:cNvPr>
          <p:cNvSpPr/>
          <p:nvPr/>
        </p:nvSpPr>
        <p:spPr>
          <a:xfrm>
            <a:off x="5194928" y="4573687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17" name="Ovale 16">
            <a:extLst>
              <a:ext uri="{FF2B5EF4-FFF2-40B4-BE49-F238E27FC236}">
                <a16:creationId xmlns:a16="http://schemas.microsoft.com/office/drawing/2014/main" id="{5EC3835A-A537-9CDA-2808-E3B8C2872224}"/>
              </a:ext>
            </a:extLst>
          </p:cNvPr>
          <p:cNvSpPr/>
          <p:nvPr/>
        </p:nvSpPr>
        <p:spPr>
          <a:xfrm>
            <a:off x="1526698" y="4693053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19" name="Ovale 18">
            <a:extLst>
              <a:ext uri="{FF2B5EF4-FFF2-40B4-BE49-F238E27FC236}">
                <a16:creationId xmlns:a16="http://schemas.microsoft.com/office/drawing/2014/main" id="{B7405B3B-47FC-6B45-013A-6071367BE8CF}"/>
              </a:ext>
            </a:extLst>
          </p:cNvPr>
          <p:cNvSpPr/>
          <p:nvPr/>
        </p:nvSpPr>
        <p:spPr>
          <a:xfrm>
            <a:off x="2043963" y="4689492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2" name="CasellaDiTesto 27">
            <a:extLst>
              <a:ext uri="{FF2B5EF4-FFF2-40B4-BE49-F238E27FC236}">
                <a16:creationId xmlns:a16="http://schemas.microsoft.com/office/drawing/2014/main" id="{717DF0BF-6890-6805-74F6-BF454D61C104}"/>
              </a:ext>
            </a:extLst>
          </p:cNvPr>
          <p:cNvSpPr txBox="1"/>
          <p:nvPr/>
        </p:nvSpPr>
        <p:spPr>
          <a:xfrm>
            <a:off x="1209746" y="3792274"/>
            <a:ext cx="167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bg1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CasellaDiTesto 28">
            <a:extLst>
              <a:ext uri="{FF2B5EF4-FFF2-40B4-BE49-F238E27FC236}">
                <a16:creationId xmlns:a16="http://schemas.microsoft.com/office/drawing/2014/main" id="{6DE8A140-42DE-3B30-478E-BE9484A19C75}"/>
              </a:ext>
            </a:extLst>
          </p:cNvPr>
          <p:cNvSpPr txBox="1"/>
          <p:nvPr/>
        </p:nvSpPr>
        <p:spPr>
          <a:xfrm>
            <a:off x="2666901" y="3791127"/>
            <a:ext cx="167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bg1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CasellaDiTesto 29">
            <a:extLst>
              <a:ext uri="{FF2B5EF4-FFF2-40B4-BE49-F238E27FC236}">
                <a16:creationId xmlns:a16="http://schemas.microsoft.com/office/drawing/2014/main" id="{03F4D136-0034-0053-EE90-EA1EB5062E60}"/>
              </a:ext>
            </a:extLst>
          </p:cNvPr>
          <p:cNvSpPr txBox="1"/>
          <p:nvPr/>
        </p:nvSpPr>
        <p:spPr>
          <a:xfrm>
            <a:off x="4271450" y="3793786"/>
            <a:ext cx="167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bg1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5592192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C1F047E-BB9F-18D5-66FA-A072210A615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Viso umano, Barba umana, cielo, Fronte&#10;&#10;Descrizione generata automaticamente">
            <a:extLst>
              <a:ext uri="{FF2B5EF4-FFF2-40B4-BE49-F238E27FC236}">
                <a16:creationId xmlns:a16="http://schemas.microsoft.com/office/drawing/2014/main" id="{A8E32EB0-EBF9-0E44-8572-67CDFC9768A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15909" y="3694476"/>
            <a:ext cx="1624202" cy="2376041"/>
          </a:xfrm>
          <a:prstGeom prst="rect">
            <a:avLst/>
          </a:prstGeom>
        </p:spPr>
      </p:pic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41CCA2E7-D63F-6958-1BDF-E6435D831AE6}"/>
              </a:ext>
            </a:extLst>
          </p:cNvPr>
          <p:cNvSpPr txBox="1"/>
          <p:nvPr/>
        </p:nvSpPr>
        <p:spPr>
          <a:xfrm>
            <a:off x="3559195" y="5873813"/>
            <a:ext cx="167458" cy="2099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6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Ovale 16">
            <a:extLst>
              <a:ext uri="{FF2B5EF4-FFF2-40B4-BE49-F238E27FC236}">
                <a16:creationId xmlns:a16="http://schemas.microsoft.com/office/drawing/2014/main" id="{1CA16146-F607-FCD4-6900-D798687E4EB8}"/>
              </a:ext>
            </a:extLst>
          </p:cNvPr>
          <p:cNvSpPr/>
          <p:nvPr/>
        </p:nvSpPr>
        <p:spPr>
          <a:xfrm>
            <a:off x="2230249" y="4659560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19" name="Ovale 18">
            <a:extLst>
              <a:ext uri="{FF2B5EF4-FFF2-40B4-BE49-F238E27FC236}">
                <a16:creationId xmlns:a16="http://schemas.microsoft.com/office/drawing/2014/main" id="{CE3B766B-8664-9049-AE25-A3D366540847}"/>
              </a:ext>
            </a:extLst>
          </p:cNvPr>
          <p:cNvSpPr/>
          <p:nvPr/>
        </p:nvSpPr>
        <p:spPr>
          <a:xfrm>
            <a:off x="2853013" y="4659560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AA47FB9C-0C4D-E23B-E9DA-50F56A4AFB07}"/>
              </a:ext>
            </a:extLst>
          </p:cNvPr>
          <p:cNvSpPr txBox="1"/>
          <p:nvPr/>
        </p:nvSpPr>
        <p:spPr>
          <a:xfrm>
            <a:off x="1904379" y="6064221"/>
            <a:ext cx="3269476" cy="8121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8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Figure S2: </a:t>
            </a:r>
            <a:r>
              <a:rPr lang="en-US" sz="8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(A) </a:t>
            </a:r>
            <a:r>
              <a:rPr lang="en-US" sz="800" dirty="0">
                <a:solidFill>
                  <a:srgbClr val="FF0000"/>
                </a:solidFill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symmetric b</a:t>
            </a:r>
            <a:r>
              <a:rPr lang="en-US" sz="8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ilateral temporal hollowing with peri-zygomatic bulging 1 year after bilateral </a:t>
            </a:r>
            <a:r>
              <a:rPr lang="en-US" sz="8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fronto</a:t>
            </a:r>
            <a:r>
              <a:rPr lang="en-US" sz="8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-temporal craniectomy. (B) </a:t>
            </a:r>
            <a:r>
              <a:rPr lang="en-US" sz="800" dirty="0">
                <a:solidFill>
                  <a:srgbClr val="FF0000"/>
                </a:solidFill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12</a:t>
            </a:r>
            <a:r>
              <a:rPr lang="en-US" sz="8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months after after inset of a unilateral double-layered adipo-dermal graft harvested from the supra-pubic area.</a:t>
            </a:r>
          </a:p>
        </p:txBody>
      </p:sp>
      <p:pic>
        <p:nvPicPr>
          <p:cNvPr id="4" name="Immagine 3" descr="Immagine che contiene Viso umano, Barba umana, uomo, persona&#10;&#10;Descrizione generata automaticamente">
            <a:extLst>
              <a:ext uri="{FF2B5EF4-FFF2-40B4-BE49-F238E27FC236}">
                <a16:creationId xmlns:a16="http://schemas.microsoft.com/office/drawing/2014/main" id="{B87AF694-3D4E-2BBF-2D8D-2C0CD23AC42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0493" t="10362" r="35301" b="12420"/>
          <a:stretch/>
        </p:blipFill>
        <p:spPr>
          <a:xfrm>
            <a:off x="3539117" y="3693460"/>
            <a:ext cx="1625431" cy="2374298"/>
          </a:xfrm>
          <a:prstGeom prst="rect">
            <a:avLst/>
          </a:prstGeom>
        </p:spPr>
      </p:pic>
      <p:sp>
        <p:nvSpPr>
          <p:cNvPr id="13" name="Ovale 12">
            <a:extLst>
              <a:ext uri="{FF2B5EF4-FFF2-40B4-BE49-F238E27FC236}">
                <a16:creationId xmlns:a16="http://schemas.microsoft.com/office/drawing/2014/main" id="{F7F4E0A2-5240-3D3A-EC1E-9EDAEC765C60}"/>
              </a:ext>
            </a:extLst>
          </p:cNvPr>
          <p:cNvSpPr/>
          <p:nvPr/>
        </p:nvSpPr>
        <p:spPr>
          <a:xfrm>
            <a:off x="3864987" y="4659560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12" name="Ovale 11">
            <a:extLst>
              <a:ext uri="{FF2B5EF4-FFF2-40B4-BE49-F238E27FC236}">
                <a16:creationId xmlns:a16="http://schemas.microsoft.com/office/drawing/2014/main" id="{67C0A040-2463-BC15-3F77-4E1BBC071DE8}"/>
              </a:ext>
            </a:extLst>
          </p:cNvPr>
          <p:cNvSpPr/>
          <p:nvPr/>
        </p:nvSpPr>
        <p:spPr>
          <a:xfrm>
            <a:off x="4514766" y="4659560"/>
            <a:ext cx="377683" cy="186709"/>
          </a:xfrm>
          <a:prstGeom prst="ellips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938" dirty="0">
              <a:solidFill>
                <a:sysClr val="windowText" lastClr="000000"/>
              </a:solidFill>
            </a:endParaRPr>
          </a:p>
        </p:txBody>
      </p:sp>
      <p:sp>
        <p:nvSpPr>
          <p:cNvPr id="3" name="CasellaDiTesto 27">
            <a:extLst>
              <a:ext uri="{FF2B5EF4-FFF2-40B4-BE49-F238E27FC236}">
                <a16:creationId xmlns:a16="http://schemas.microsoft.com/office/drawing/2014/main" id="{0E613D23-D04B-AE31-8EC7-D4B219710AC6}"/>
              </a:ext>
            </a:extLst>
          </p:cNvPr>
          <p:cNvSpPr txBox="1"/>
          <p:nvPr/>
        </p:nvSpPr>
        <p:spPr>
          <a:xfrm>
            <a:off x="1914678" y="3692018"/>
            <a:ext cx="167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bg1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CasellaDiTesto 5">
            <a:extLst>
              <a:ext uri="{FF2B5EF4-FFF2-40B4-BE49-F238E27FC236}">
                <a16:creationId xmlns:a16="http://schemas.microsoft.com/office/drawing/2014/main" id="{6A0F0A15-C99F-29E4-00DD-D49ACC83F45B}"/>
              </a:ext>
            </a:extLst>
          </p:cNvPr>
          <p:cNvSpPr txBox="1"/>
          <p:nvPr/>
        </p:nvSpPr>
        <p:spPr>
          <a:xfrm>
            <a:off x="3529807" y="3692018"/>
            <a:ext cx="1674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solidFill>
                  <a:schemeClr val="bg1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328922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07</Words>
  <Application>Microsoft Office PowerPoint</Application>
  <PresentationFormat>Custom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avide Brucato</dc:creator>
  <cp:lastModifiedBy>MDPI</cp:lastModifiedBy>
  <cp:revision>9</cp:revision>
  <dcterms:created xsi:type="dcterms:W3CDTF">2024-03-25T15:53:57Z</dcterms:created>
  <dcterms:modified xsi:type="dcterms:W3CDTF">2024-08-21T12:55:21Z</dcterms:modified>
</cp:coreProperties>
</file>